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2EB2C-186E-4D58-BB41-68BBE6A7B9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1DA1D-DCAB-4C96-83DE-6457E14E23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92325-8005-4DA0-91E7-17D7ACAB62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DA7EB-BAFD-4D98-997D-50F35E3128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9FF5B-030C-4D2A-98FD-36EE0CE75D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08D1C-735F-493D-95B9-FEB5A9FDA7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78A31-FAAE-4CC0-ACCE-C1EFB767F9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6811F-72B2-4E54-BC7B-B273F210D7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A3324-2D0E-4E8F-A273-DBE242D4CF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11660-F90F-457C-8E63-42E50EE847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D2BA7-31E5-4C13-B506-864FF95386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5BC3D-69F7-4EF3-B7D3-4DCCEA0F22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9AC99F-3475-4F40-8942-059C08421B3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982880" y="206280"/>
            <a:ext cx="5533200" cy="2616480"/>
            <a:chOff x="1982880" y="206280"/>
            <a:chExt cx="5533200" cy="2616480"/>
          </a:xfrm>
        </p:grpSpPr>
        <p:sp>
          <p:nvSpPr>
            <p:cNvPr id="42" name=""/>
            <p:cNvSpPr/>
            <p:nvPr/>
          </p:nvSpPr>
          <p:spPr>
            <a:xfrm>
              <a:off x="2179440" y="398520"/>
              <a:ext cx="1186200" cy="11858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349720" y="820800"/>
              <a:ext cx="918360" cy="41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pLZ-htrA</a:t>
              </a:r>
              <a:r>
                <a:rPr b="0" lang="ja-JP" sz="1000" spc="-1" strike="noStrike" baseline="-25000">
                  <a:solidFill>
                    <a:srgbClr val="000000"/>
                  </a:solidFill>
                  <a:latin typeface="Arial"/>
                </a:rPr>
                <a:t>forwar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6.0 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213000" y="1388880"/>
              <a:ext cx="52560" cy="4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203640" y="1312920"/>
              <a:ext cx="1839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176560" y="401760"/>
              <a:ext cx="1186560" cy="118656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2931" y="18197"/>
                  </a:moveTo>
                  <a:arcTo wR="10800" hR="10800" stAng="8206322" swAng="5050647"/>
                  <a:lnTo>
                    <a:pt x="10800" y="10800"/>
                  </a:lnTo>
                  <a:close/>
                </a:path>
                <a:path fill="none" w="21600" h="21600">
                  <a:moveTo>
                    <a:pt x="2931" y="18197"/>
                  </a:moveTo>
                  <a:arcTo wR="10800" hR="10800" stAng="8206322" swAng="5050647"/>
                </a:path>
              </a:pathLst>
            </a:custGeom>
            <a:noFill/>
            <a:ln w="38160">
              <a:solidFill>
                <a:srgbClr val="ff000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1881360" y="891000"/>
              <a:ext cx="41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aph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178360" y="396720"/>
              <a:ext cx="1188000" cy="118764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4320" y="2160"/>
                  </a:moveTo>
                  <a:arcTo wR="10800" hR="10800" stAng="-7612258" swAng="3785459"/>
                  <a:lnTo>
                    <a:pt x="10800" y="10800"/>
                  </a:lnTo>
                  <a:close/>
                </a:path>
                <a:path fill="none" w="21600" h="21600">
                  <a:moveTo>
                    <a:pt x="4320" y="2160"/>
                  </a:moveTo>
                  <a:arcTo wR="10800" hR="10800" stAng="-7612258" swAng="3785459"/>
                </a:path>
              </a:pathLst>
            </a:custGeom>
            <a:noFill/>
            <a:ln w="38160">
              <a:solidFill>
                <a:srgbClr val="ffff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37280" y="206280"/>
              <a:ext cx="39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re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170080" y="396360"/>
              <a:ext cx="1186920" cy="118512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16506" y="1630"/>
                  </a:moveTo>
                  <a:arcTo wR="10800" hR="10800" stAng="-3486496" swAng="1397324"/>
                  <a:lnTo>
                    <a:pt x="10800" y="10800"/>
                  </a:lnTo>
                  <a:close/>
                </a:path>
                <a:path fill="none" w="21600" h="21600">
                  <a:moveTo>
                    <a:pt x="16506" y="1630"/>
                  </a:moveTo>
                  <a:arcTo wR="10800" hR="10800" stAng="-3486496" swAng="1397324"/>
                </a:path>
              </a:pathLst>
            </a:custGeom>
            <a:noFill/>
            <a:ln w="38160">
              <a:solidFill>
                <a:srgbClr val="ffff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111480" y="401760"/>
              <a:ext cx="72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copG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 famil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187800" y="1414440"/>
              <a:ext cx="5220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013200" y="1446120"/>
              <a:ext cx="36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Not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 flipV="1">
              <a:off x="2302920" y="528480"/>
              <a:ext cx="4284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>
              <a:off x="2494080" y="1531800"/>
              <a:ext cx="3312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89000" y="36360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Sal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76280" y="154152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Sal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267000" y="1439640"/>
              <a:ext cx="274680" cy="92412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3267000" y="1073160"/>
              <a:ext cx="933480" cy="36648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7023600">
              <a:off x="3313440" y="1715400"/>
              <a:ext cx="1233720" cy="215640"/>
            </a:xfrm>
            <a:custGeom>
              <a:avLst/>
              <a:gdLst>
                <a:gd name="textAreaLeft" fmla="*/ 0 w 1233720"/>
                <a:gd name="textAreaRight" fmla="*/ 1234080 w 1233720"/>
                <a:gd name="textAreaTop" fmla="*/ 0 h 215640"/>
                <a:gd name="textAreaBottom" fmla="*/ 216000 h 215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1000" spc="-1" strike="noStrike">
                  <a:solidFill>
                    <a:srgbClr val="000000"/>
                  </a:solidFill>
                  <a:latin typeface="Arial"/>
                </a:rPr>
                <a:t>ht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3538080" y="1069560"/>
              <a:ext cx="654840" cy="128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H="1" flipV="1">
              <a:off x="4196880" y="1075320"/>
              <a:ext cx="128520" cy="6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 flipV="1">
              <a:off x="3541320" y="2358000"/>
              <a:ext cx="128520" cy="6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7023600">
              <a:off x="4203720" y="96840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Eco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7023600">
              <a:off x="3440520" y="246060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Eco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060880" y="398520"/>
              <a:ext cx="1185840" cy="11858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232600" y="820800"/>
              <a:ext cx="918360" cy="41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pLZ-htrA</a:t>
              </a:r>
              <a:r>
                <a:rPr b="0" lang="ja-JP" sz="1000" spc="-1" strike="noStrike" baseline="-25000">
                  <a:solidFill>
                    <a:srgbClr val="000000"/>
                  </a:solidFill>
                  <a:latin typeface="Arial"/>
                </a:rPr>
                <a:t>rever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Arial"/>
                </a:rPr>
                <a:t>6.0 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094440" y="1388880"/>
              <a:ext cx="52200" cy="4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084720" y="1312920"/>
              <a:ext cx="1843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057640" y="401760"/>
              <a:ext cx="1187640" cy="118656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2931" y="18197"/>
                  </a:moveTo>
                  <a:arcTo wR="10800" hR="10800" stAng="8206322" swAng="5050647"/>
                  <a:lnTo>
                    <a:pt x="10800" y="10800"/>
                  </a:lnTo>
                  <a:close/>
                </a:path>
                <a:path fill="none" w="21600" h="21600">
                  <a:moveTo>
                    <a:pt x="2931" y="18197"/>
                  </a:moveTo>
                  <a:arcTo wR="10800" hR="10800" stAng="8206322" swAng="5050647"/>
                </a:path>
              </a:pathLst>
            </a:custGeom>
            <a:noFill/>
            <a:ln w="38160">
              <a:solidFill>
                <a:srgbClr val="ff000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4762440" y="891000"/>
              <a:ext cx="41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aph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059800" y="396720"/>
              <a:ext cx="1188000" cy="118764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4320" y="2160"/>
                  </a:moveTo>
                  <a:arcTo wR="10800" hR="10800" stAng="-7612258" swAng="3785459"/>
                  <a:lnTo>
                    <a:pt x="10800" y="10800"/>
                  </a:lnTo>
                  <a:close/>
                </a:path>
                <a:path fill="none" w="21600" h="21600">
                  <a:moveTo>
                    <a:pt x="4320" y="2160"/>
                  </a:moveTo>
                  <a:arcTo wR="10800" hR="10800" stAng="-7612258" swAng="3785459"/>
                </a:path>
              </a:pathLst>
            </a:custGeom>
            <a:noFill/>
            <a:ln w="38160">
              <a:solidFill>
                <a:srgbClr val="ffff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418720" y="206280"/>
              <a:ext cx="39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re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051520" y="396360"/>
              <a:ext cx="1186920" cy="1185120"/>
            </a:xfrm>
            <a:custGeom>
              <a:avLst/>
              <a:gdLst/>
              <a:ahLst/>
              <a:rect l="l" t="t" r="r" b="b"/>
              <a:pathLst>
                <a:path stroke="0" w="21600" h="21600">
                  <a:moveTo>
                    <a:pt x="16506" y="1630"/>
                  </a:moveTo>
                  <a:arcTo wR="10800" hR="10800" stAng="-3486496" swAng="1397324"/>
                  <a:lnTo>
                    <a:pt x="10800" y="10800"/>
                  </a:lnTo>
                  <a:close/>
                </a:path>
                <a:path fill="none" w="21600" h="21600">
                  <a:moveTo>
                    <a:pt x="16506" y="1630"/>
                  </a:moveTo>
                  <a:arcTo wR="10800" hR="10800" stAng="-3486496" swAng="1397324"/>
                </a:path>
              </a:pathLst>
            </a:custGeom>
            <a:noFill/>
            <a:ln w="38160">
              <a:solidFill>
                <a:srgbClr val="ffff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992920" y="401760"/>
              <a:ext cx="72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copG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 famil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068880" y="1414440"/>
              <a:ext cx="5256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894640" y="1446120"/>
              <a:ext cx="36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Not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H="1" flipV="1">
              <a:off x="5184360" y="528480"/>
              <a:ext cx="4284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5374800" y="1531800"/>
              <a:ext cx="3348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870440" y="36360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Sal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157720" y="154152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Sal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148440" y="1439640"/>
              <a:ext cx="274680" cy="92412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6148440" y="1073160"/>
              <a:ext cx="933480" cy="36648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6419160" y="1069560"/>
              <a:ext cx="654840" cy="128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 flipV="1">
              <a:off x="7078320" y="1075320"/>
              <a:ext cx="128520" cy="6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H="1" flipV="1">
              <a:off x="6422760" y="2358000"/>
              <a:ext cx="128520" cy="6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7023600">
              <a:off x="7085520" y="96876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Eco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7023600">
              <a:off x="6321960" y="246096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800" spc="-1" strike="noStrike">
                  <a:solidFill>
                    <a:srgbClr val="000000"/>
                  </a:solidFill>
                  <a:latin typeface="Arial"/>
                </a:rPr>
                <a:t>Eco</a:t>
              </a:r>
              <a:r>
                <a:rPr b="0" lang="ja-JP" sz="800" spc="-1" strike="noStrike">
                  <a:solidFill>
                    <a:srgbClr val="000000"/>
                  </a:solidFill>
                  <a:latin typeface="Arial"/>
                </a:rPr>
                <a:t>R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 rot="7020000">
              <a:off x="6258600" y="1597680"/>
              <a:ext cx="1233360" cy="215280"/>
            </a:xfrm>
            <a:custGeom>
              <a:avLst/>
              <a:gdLst>
                <a:gd name="textAreaLeft" fmla="*/ 360 w 1233360"/>
                <a:gd name="textAreaRight" fmla="*/ 1234080 w 1233360"/>
                <a:gd name="textAreaTop" fmla="*/ 0 h 215280"/>
                <a:gd name="textAreaBottom" fmla="*/ 215640 h 215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ja-JP" sz="1000" spc="-1" strike="noStrike">
                  <a:solidFill>
                    <a:srgbClr val="000000"/>
                  </a:solidFill>
                  <a:latin typeface="Arial"/>
                </a:rPr>
                <a:t>ht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"/>
          <p:cNvSpPr/>
          <p:nvPr/>
        </p:nvSpPr>
        <p:spPr>
          <a:xfrm>
            <a:off x="8300520" y="658332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1"/>
          <p:cNvSpPr>
            <a:spLocks noGrp="1"/>
          </p:cNvSpPr>
          <p:nvPr>
            <p:ph/>
          </p:nvPr>
        </p:nvSpPr>
        <p:spPr>
          <a:xfrm>
            <a:off x="0" y="2925720"/>
            <a:ext cx="9144000" cy="381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A DNA fragment containing the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gene was amplified using the oligonucleotide primers htrA-F3 (5′-CATTACTTTTTACACAATTTATCCACAAGT-3′) and htrA-R1 (5′-GTAGGTCTATCAATAATTCTTTTGTCATAA-3′), 1529 genomic DNA as the template, and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TaKaRa Ex Taq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DNA polymerase (Takara). The PCR product was cloned into the pGEM</a:t>
            </a:r>
            <a:r>
              <a:rPr b="0" lang="ja-JP" sz="1200" spc="-1" strike="noStrike" baseline="30000">
                <a:solidFill>
                  <a:srgbClr val="000000"/>
                </a:solidFill>
                <a:latin typeface="Arial"/>
              </a:rPr>
              <a:t>®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-T Easy vector (Promega), and the resulting plasmid (pIT422) was used to transform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Escherichia coli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strain DH5α at 37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˚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. The insert in pIT422 was sequenced, and the following two mutations were found: (i) substitution of the start codon ATG to CTG, and (ii) the 165th codon (TCT, encoding Ser) was changed to GCT (Ala). To restore the mutated 165th codon of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on pIT422 to its original codon TCT (Ser), inverse PCR was conducted using two primers, htrA-165 F (5′-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CT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TCAGATAAAAACAGT-3′) and htrA-165R (5′-GATCTTAACAACAGCTAAATCC-3′), pIT422 plasmid DNA as template, and PrimeSTAR HS DNA polymerase (Takara). Oligonucleotide htrA-165 F contained the 165th codon TCT of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(shown in bold in the primer sequence). This blunt-ended PCR product was treated with T4 polynucleotide kinase (Takara), self ligated to yield pIT423, and used to transform the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strain DH5α at 37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˚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. To construct a plasmid containing intact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, further inverse PCR was conducted using two primers, htrA-1 F (5′-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ATG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CAAGTATGAAACATATCTT-3′) and htrA-startR (5′-GTTTTGTCCTCCGAATTATTTG-3′), and pIT423 plasmid DNA as template, to restore the mutated start codon of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on pIT423 to the original codon ATG. Oligonucleotide htrA-1 F contained the start codon ATG of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(shown in bold in the primer sequence). This blunt-ended PCR product was self ligated to yield pIT428, and used to transform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strain DH5α at 37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˚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. The transformant with pIT428 had very little growth ability at 37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˚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 to prepare a sufficient amount of plasmid DNA for DNA sequencing. Therefore, the insert in pIT428 was amplified by PCR using the primers htrA-F3 and htrA-R1, and sequenced. The resultant plasmid (pIT428) was digested with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Eco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RI and ligated into the same site of the pLZ12-Km2 plasmid [25]. The ligated DNA was introduced into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strain DH5α at 30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˚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C, and we could finally obtain eight transformants with successful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i="1" lang="ja-JP" sz="1200" spc="-1" strike="noStrike" baseline="-2000">
                <a:solidFill>
                  <a:srgbClr val="000000"/>
                </a:solidFill>
                <a:latin typeface="Arial"/>
              </a:rPr>
              <a:t>py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clones. The resulting plasmids containing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i="1" lang="ja-JP" sz="1200" spc="-1" strike="noStrike" baseline="-2000">
                <a:solidFill>
                  <a:srgbClr val="000000"/>
                </a:solidFill>
                <a:latin typeface="Arial"/>
              </a:rPr>
              <a:t>py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from the seven out of the eight transformants were named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forward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. The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i="1" lang="ja-JP" sz="1200" spc="-1" strike="noStrike" baseline="-2000">
                <a:solidFill>
                  <a:srgbClr val="000000"/>
                </a:solidFill>
                <a:latin typeface="Arial"/>
              </a:rPr>
              <a:t>py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from the remaining transformant, was cloned into pLZ12-Km2 in the opposite direction compared to that in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forward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, and the resulting plasmid was named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revers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. Only one transformant out of eight contained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revers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. The probability of this occurring was 0.032 (= 8/28), if the null hypothesis is that the direction of the cloned </a:t>
            </a:r>
            <a:r>
              <a:rPr b="0" i="1" lang="ja-JP" sz="1200" spc="-1" strike="noStrike">
                <a:solidFill>
                  <a:srgbClr val="000000"/>
                </a:solidFill>
                <a:latin typeface="Arial"/>
              </a:rPr>
              <a:t>htrA</a:t>
            </a:r>
            <a:r>
              <a:rPr b="0" i="1" lang="ja-JP" sz="1200" spc="-1" strike="noStrike" baseline="-2000">
                <a:solidFill>
                  <a:srgbClr val="000000"/>
                </a:solidFill>
                <a:latin typeface="Arial"/>
              </a:rPr>
              <a:t>py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in the vector was randomly decided. Therefore, we hypothesized that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revers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is more toxic to the bacterial host than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forward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, i.e., the level of HtrA expression from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reverse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is greater than that by pLZ-htrA</a:t>
            </a:r>
            <a:r>
              <a:rPr b="0" lang="ja-JP" sz="1200" spc="-1" strike="noStrike" baseline="-2000">
                <a:solidFill>
                  <a:srgbClr val="000000"/>
                </a:solidFill>
                <a:latin typeface="Arial"/>
              </a:rPr>
              <a:t>forward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 (see text for details). This hypothesis was also verified by qRT-PCR (Additional file 3: Figure S3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1T08:19:53Z</dcterms:created>
  <dc:creator>ichiro_tatsuno</dc:creator>
  <dc:description/>
  <dc:language>en-US</dc:language>
  <cp:lastModifiedBy>ichiro_tatsuno</cp:lastModifiedBy>
  <dcterms:modified xsi:type="dcterms:W3CDTF">2014-03-31T05:08:48Z</dcterms:modified>
  <cp:revision>20</cp:revision>
  <dc:subject/>
  <dc:title>スライド 1</dc:title>
</cp:coreProperties>
</file>